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C99C6-D875-7C2B-0219-4865539F56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C4DE2D-62F7-CE6E-88BE-EDCD289701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38D1D3-D18B-809C-B621-466800FC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EFB0D-366D-9101-A356-40F7B2BE0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172FFF-8754-AE73-CBDF-7F09282A1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858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91F9F-C4E1-7383-61B2-28C690149B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45DBF6-1B9C-DC97-7CFB-2F696EF901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0531F2-0AEB-6312-4B06-A06287DF3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EC30D3-0DE3-13B6-FD63-958327380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BAF1AA-8A9A-47A2-E34E-1324C076C9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155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AECDC4-75D7-97F9-603E-585256D8BB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BB03B8-6E38-24C2-E7C7-29A0224C57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124E3A-B9D8-4C2C-F1A4-4B1C7D254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885A02-03C5-A371-D823-D2A5AA2F7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CC4F61-5984-3740-349E-786D1FBB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732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9491C5-4F56-0279-06E3-06DCDE6275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E4B34C-BB17-D4B8-938A-EB90A33873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DDAA12-C6B6-456F-599A-290CDF1BE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317412-68CF-1CD9-CDF1-C9A69DBA5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AA25A-CC3C-D94C-4DD3-1D23EE386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957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93A38A-18E2-B340-4558-29A8F04C6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10B298-F052-6E81-15B7-AE5FCB790C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9DCFB5-807C-B115-44C1-0D523C54F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50ECA-54B9-797B-5FD2-06F673875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DAC390-73FD-EB58-33C8-2CFDE0F83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799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781AA-1DA6-9AEC-3723-CC821909C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80885D-294A-5C62-E8BF-E0BAF54E55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D3DD98-517D-B27A-5084-42ED7815B8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5D2E59-83FA-D058-6A28-00D468706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2F7ED3-0FF8-87E8-9580-F87EE4F91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DA6EC6-0B96-D849-6947-03C23D418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02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5CCA0-5C8D-560E-D361-A41D9D9A0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6CF8CA-E028-0782-E187-3DE9F8CD1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C88741-4593-14C9-BE27-B8AD41293C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01F0D3-D739-56E6-6524-D4DD08750D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C5899F-5C53-9A25-5C20-E48C7B03A7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CB6C80-F846-E289-B41D-EAB9A8AB7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C0E730-2AD8-5FD8-E727-517B3A84D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CCBAC9-92E3-27FC-7FED-1F494A610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58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851F75-3AFC-4D4F-8610-93C9E2B03F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7C5152A-B0B5-D334-F0AE-53C0B1E2A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B57515-00A9-C731-74C6-B37C9B998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68E236-0189-A09E-30D3-49B7719AF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720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5370AD-8647-996E-C9CE-2771A23631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B022C44-8D00-A28F-7527-E96C80A69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2A01A5-E899-915D-62B2-4C2EFFC6A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397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48223-E7CD-5CCA-30DD-16B55278B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714B84-050E-9939-D44E-AF9D93917B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38AF17-2FB2-39FC-496F-69B40B6217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579341-8343-A9CA-D920-64EB19E9C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48FEA1-8D14-8FD8-7E14-84B327C10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F660DB-FCA8-A60E-D218-0AFED9978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624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6642ED-6929-6531-317C-651E66D4B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F4932B-C23B-AA14-2069-F25967F404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CEC681-1D51-28B4-E234-6CC25C138A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8D5DD1-3A34-2272-2ED0-AC22E537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2223AB-E7F1-B174-DF46-C13F9E951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0BABB9-A5F3-550A-9FED-93B04C106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190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6255B3-E8B7-8806-512F-C236A36C90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C08207-C762-458B-5E04-16FEFDF89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DE1E37-801B-E30B-6F9A-A7FAC3AD28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07DD7A-15D9-F046-A8A7-EB8646461EEE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4BD23D-82E1-3CC3-A5F8-3B68E1FA1E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6B58CD-3314-A976-58B2-7C3E331AE0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B37FCA-86D2-5947-8D46-E0707278A1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244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table with text on it&#10;&#10;AI-generated content may be incorrect.">
            <a:extLst>
              <a:ext uri="{FF2B5EF4-FFF2-40B4-BE49-F238E27FC236}">
                <a16:creationId xmlns:a16="http://schemas.microsoft.com/office/drawing/2014/main" id="{839FB70E-9A7B-CB82-A5FC-FBF3E6CABE5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367" b="1726"/>
          <a:stretch/>
        </p:blipFill>
        <p:spPr>
          <a:xfrm>
            <a:off x="234087" y="495994"/>
            <a:ext cx="11723825" cy="21006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3347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0D93273-824C-F31D-3C44-6F61FA6DFC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1287647"/>
              </p:ext>
            </p:extLst>
          </p:nvPr>
        </p:nvGraphicFramePr>
        <p:xfrm>
          <a:off x="234087" y="2058186"/>
          <a:ext cx="11723826" cy="2204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01309">
                  <a:extLst>
                    <a:ext uri="{9D8B030D-6E8A-4147-A177-3AD203B41FA5}">
                      <a16:colId xmlns:a16="http://schemas.microsoft.com/office/drawing/2014/main" val="3983524944"/>
                    </a:ext>
                  </a:extLst>
                </a:gridCol>
                <a:gridCol w="2488019">
                  <a:extLst>
                    <a:ext uri="{9D8B030D-6E8A-4147-A177-3AD203B41FA5}">
                      <a16:colId xmlns:a16="http://schemas.microsoft.com/office/drawing/2014/main" val="2560651380"/>
                    </a:ext>
                  </a:extLst>
                </a:gridCol>
                <a:gridCol w="2509284">
                  <a:extLst>
                    <a:ext uri="{9D8B030D-6E8A-4147-A177-3AD203B41FA5}">
                      <a16:colId xmlns:a16="http://schemas.microsoft.com/office/drawing/2014/main" val="962607129"/>
                    </a:ext>
                  </a:extLst>
                </a:gridCol>
                <a:gridCol w="2626242">
                  <a:extLst>
                    <a:ext uri="{9D8B030D-6E8A-4147-A177-3AD203B41FA5}">
                      <a16:colId xmlns:a16="http://schemas.microsoft.com/office/drawing/2014/main" val="1627648767"/>
                    </a:ext>
                  </a:extLst>
                </a:gridCol>
                <a:gridCol w="1945758">
                  <a:extLst>
                    <a:ext uri="{9D8B030D-6E8A-4147-A177-3AD203B41FA5}">
                      <a16:colId xmlns:a16="http://schemas.microsoft.com/office/drawing/2014/main" val="2799309482"/>
                    </a:ext>
                  </a:extLst>
                </a:gridCol>
                <a:gridCol w="953214">
                  <a:extLst>
                    <a:ext uri="{9D8B030D-6E8A-4147-A177-3AD203B41FA5}">
                      <a16:colId xmlns:a16="http://schemas.microsoft.com/office/drawing/2014/main" val="2449034325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astrointestinal Disorders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87482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CTCAE Ter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rade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rade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rade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rade 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Grade 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8706027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Diarrhe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ncrease of &lt;4 stools per day over baseline; mild increase in ostomy output compared to basel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ncrease of 4-6 stools per day over baseline; moderate increase in ostomy output compared to baseline; limiting instrumental A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ncrease of &gt;=7 stools per day over baseline; hospitalization indicated; severe increase in ostomy output compared to baseline; limiting self care A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Life-threatening consequences; urgent intervention indicat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Death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723008"/>
                  </a:ext>
                </a:extLst>
              </a:tr>
              <a:tr h="370840">
                <a:tc gridSpan="6">
                  <a:txBody>
                    <a:bodyPr/>
                    <a:lstStyle/>
                    <a:p>
                      <a:pPr algn="l"/>
                      <a:r>
                        <a:rPr lang="en-US" sz="1400" b="1" dirty="0"/>
                        <a:t>Definition: </a:t>
                      </a:r>
                      <a:r>
                        <a:rPr lang="en-US" sz="1400" dirty="0"/>
                        <a:t>A disorder characterized by an in crease in frequency and/or loose watery bowel movements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3975368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76067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05</Words>
  <Application>Microsoft Macintosh PowerPoint</Application>
  <PresentationFormat>Widescreen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rees, Zachary</dc:creator>
  <cp:lastModifiedBy>Crees, Zachary</cp:lastModifiedBy>
  <cp:revision>3</cp:revision>
  <dcterms:created xsi:type="dcterms:W3CDTF">2025-10-24T05:01:39Z</dcterms:created>
  <dcterms:modified xsi:type="dcterms:W3CDTF">2025-11-07T14:01:13Z</dcterms:modified>
</cp:coreProperties>
</file>